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 varScale="1">
        <p:scale>
          <a:sx n="99" d="100"/>
          <a:sy n="99" d="100"/>
        </p:scale>
        <p:origin x="4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25470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54070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14210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22625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01817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38503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86652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957269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32017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36643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0791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3CD12-E17D-4AB1-8F1E-91210064E733}" type="datetimeFigureOut">
              <a:rPr lang="fr-CH" smtClean="0"/>
              <a:t>23.03.2021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EFAC3-9457-443F-88D4-A318F12AE374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06072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18306" y="6211669"/>
            <a:ext cx="11353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Additional file Figure </a:t>
            </a:r>
            <a:r>
              <a:rPr lang="en-US" b="1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S1.. 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ar regression analysis of the relationship between changes in ScvO</a:t>
            </a:r>
            <a:r>
              <a:rPr lang="en-US" baseline="-25000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CI after PLR. </a:t>
            </a:r>
            <a:r>
              <a:rPr lang="en-US" i="1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 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 0.05 was considered significant.</a:t>
            </a:r>
            <a:endParaRPr lang="fr-CH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1692" y="-7052"/>
            <a:ext cx="7388616" cy="6179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3291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04006" y="6164263"/>
            <a:ext cx="115824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dditional file Figure S2. 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inear regression analysis of the relationship between changes in ScvO</a:t>
            </a:r>
            <a:r>
              <a:rPr lang="en-US" baseline="-25000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CI after VE. </a:t>
            </a:r>
            <a:r>
              <a:rPr lang="en-US" i="1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 </a:t>
            </a:r>
            <a:r>
              <a:rPr lang="en-US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&lt; 0.05 was considered significant.</a:t>
            </a:r>
            <a:endParaRPr lang="fr-CH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4" name="Objet 3"/>
          <p:cNvGraphicFramePr>
            <a:graphicFrameLocks noChangeAspect="1"/>
          </p:cNvGraphicFramePr>
          <p:nvPr>
            <p:extLst/>
          </p:nvPr>
        </p:nvGraphicFramePr>
        <p:xfrm>
          <a:off x="2959025" y="-33614"/>
          <a:ext cx="6273950" cy="61708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6" r:id="rId3" imgW="7162379" imgH="7045333" progId="Prism6.Document">
                  <p:embed/>
                </p:oleObj>
              </mc:Choice>
              <mc:Fallback>
                <p:oleObj name="Prism 6" r:id="rId3" imgW="7162379" imgH="704533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59025" y="-33614"/>
                        <a:ext cx="6273950" cy="61708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074962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Grand écran</PresentationFormat>
  <Paragraphs>2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ism 6</vt:lpstr>
      <vt:lpstr>Présentation PowerPoint</vt:lpstr>
      <vt:lpstr>Présentation PowerPoint</vt:lpstr>
    </vt:vector>
  </TitlesOfParts>
  <Company>Hôpitaux Universitaires de Genèv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IRAUD Raphael</dc:creator>
  <cp:lastModifiedBy>GIRAUD Raphael</cp:lastModifiedBy>
  <cp:revision>1</cp:revision>
  <dcterms:created xsi:type="dcterms:W3CDTF">2021-03-23T09:59:11Z</dcterms:created>
  <dcterms:modified xsi:type="dcterms:W3CDTF">2021-03-23T09:59:32Z</dcterms:modified>
</cp:coreProperties>
</file>